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69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3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69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946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241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6643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468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5005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1372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20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8249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503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281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03BC5-3B9D-4A43-A998-6968159B76C8}" type="datetimeFigureOut">
              <a:rPr kumimoji="1" lang="ja-JP" altLang="en-US" smtClean="0"/>
              <a:t>2021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2A270-95B0-4523-8A3B-7FB36FFE8C1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2864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="" xmlns:a16="http://schemas.microsoft.com/office/drawing/2014/main" id="{863588D6-E587-4959-A0C3-8E33AE649D7E}"/>
              </a:ext>
            </a:extLst>
          </p:cNvPr>
          <p:cNvSpPr/>
          <p:nvPr/>
        </p:nvSpPr>
        <p:spPr>
          <a:xfrm>
            <a:off x="226584" y="6932222"/>
            <a:ext cx="6237331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Figure S1. Expression profiles of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b="1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itin synthase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, including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A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B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C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D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E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F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4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G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H), and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I) on soybean leaves.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Soybean plants were spray-inoculated with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1 x 10</a:t>
            </a:r>
            <a:r>
              <a:rPr lang="en-US" altLang="ja-JP" sz="1200" baseline="300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spores/ml). Total RNAs including soybean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were purified at 0, 2, 4, 6, 12, and 24 hours after inoculation, and expression profiles were evaluated using RT-qPCR.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longation factor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EF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ubiquitin 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UBQ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were used to normalize the samples. Vertical bars indicate the standard error of the means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= 4). Asterisks indicate a significant difference between 0 h and each time point in a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est (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5, *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1).</a:t>
            </a:r>
            <a:endParaRPr lang="ja-JP" altLang="ja-JP" sz="12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18714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312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="" xmlns:a16="http://schemas.microsoft.com/office/drawing/2014/main" id="{863588D6-E587-4959-A0C3-8E33AE649D7E}"/>
              </a:ext>
            </a:extLst>
          </p:cNvPr>
          <p:cNvSpPr/>
          <p:nvPr/>
        </p:nvSpPr>
        <p:spPr>
          <a:xfrm>
            <a:off x="226584" y="6932222"/>
            <a:ext cx="6237331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ry Figure S2. Expression profiles of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b="1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itin synthase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s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, including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A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B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2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C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D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E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3-3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F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4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G),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1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H), and </a:t>
            </a:r>
            <a:r>
              <a:rPr lang="en-US" altLang="ja-JP" sz="1200" b="1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5-2</a:t>
            </a:r>
            <a:r>
              <a:rPr lang="en-US" altLang="ja-JP" sz="1200" b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I) on polyethylene tapes treated with double-stranded RNA.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Down-regulation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of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s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ranscripts were quantified on polyethylene tapes treated with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GF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dsRNA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CHS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dsRNA. Polyethylene tapes were spray-inoculated with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1 x 10</a:t>
            </a:r>
            <a:r>
              <a:rPr lang="en-US" altLang="ja-JP" sz="1200" baseline="300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spores/ml). Total RNAs of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were purified 6 hours after inoculation, and expression profiles were evaluated using RT-qPCR.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. </a:t>
            </a:r>
            <a:r>
              <a:rPr lang="en-US" altLang="ja-JP" sz="1200" i="1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achyrhizi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elongation factor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EF1</a:t>
            </a:r>
            <a:r>
              <a:rPr lang="en-US" altLang="ja-JP" sz="1200" i="1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and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ubiquitin 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pUBQ5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were used to normalize the samples. Vertical bars indicate the standard error of the means (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n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= 4). Asterisks indicate a significant difference between 0 time and each time point in a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test (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5, ** </a:t>
            </a:r>
            <a:r>
              <a:rPr lang="en-US" altLang="ja-JP" sz="1200" i="1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p</a:t>
            </a:r>
            <a:r>
              <a:rPr lang="en-US" altLang="ja-JP" sz="12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&lt; 0.01).</a:t>
            </a:r>
            <a:endParaRPr lang="ja-JP" altLang="ja-JP" sz="12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23326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89849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="" xmlns:a16="http://schemas.microsoft.com/office/drawing/2014/main" id="{863588D6-E587-4959-A0C3-8E33AE649D7E}"/>
              </a:ext>
            </a:extLst>
          </p:cNvPr>
          <p:cNvSpPr/>
          <p:nvPr/>
        </p:nvSpPr>
        <p:spPr>
          <a:xfrm>
            <a:off x="310334" y="6314812"/>
            <a:ext cx="6237331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3. Gene expression profiles of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oybean defense marker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defense-related genes in response to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b="1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oculation on CNF-treated leaves.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ene expression profiles of soybean defense marker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defense-related genes including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thogenesis-related protein 1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1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2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4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0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R10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enylalanine ammonia-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y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L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innamat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4-hydroxyl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4H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-coumarate CoA lig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CL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affeoyl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oenzyme A O-methyltransferase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CoAOMT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alc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ynth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S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alc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duct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J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alc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somer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oflav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ynthase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FS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, and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soflavone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reductase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F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in response to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oculation on CNF-treated leaves. Soybean plants were spray-inoculated with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1 x 10</a:t>
            </a:r>
            <a:r>
              <a:rPr lang="en-US" altLang="ja-JP" sz="1200" kern="100" baseline="300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pores/ml). Total RNAs including soybean and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. </a:t>
            </a:r>
            <a:r>
              <a:rPr lang="en-US" altLang="ja-JP" sz="1200" i="1" kern="100" dirty="0" err="1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chyrhizi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ere purified at 6, 12, and 24 hours after inoculation, and expression profiles were evaluated using RT-qPCR. Soybean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longation factor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i="1" kern="100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mEF1</a:t>
            </a:r>
            <a:r>
              <a:rPr lang="en-US" altLang="ja-JP" sz="1200" i="1" kern="100" dirty="0" smtClean="0">
                <a:effectLst/>
                <a:latin typeface="Symbol" panose="05050102010706020507" pitchFamily="18" charset="2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nd 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biquitin 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mUBQ3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re used to normalize the samples. Significant differences (</a:t>
            </a:r>
            <a:r>
              <a:rPr lang="en-US" altLang="ja-JP" sz="1200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200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) are indicated by different letters based on a Tukey’s honestly significant difference (HSD) test.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06097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127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="" xmlns:a16="http://schemas.microsoft.com/office/drawing/2014/main" id="{863588D6-E587-4959-A0C3-8E33AE649D7E}"/>
              </a:ext>
            </a:extLst>
          </p:cNvPr>
          <p:cNvSpPr/>
          <p:nvPr/>
        </p:nvSpPr>
        <p:spPr>
          <a:xfrm>
            <a:off x="226584" y="6932222"/>
            <a:ext cx="623733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4. Gene sequence and primer sets for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vitro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ranscription of </a:t>
            </a:r>
            <a:r>
              <a:rPr lang="en-US" altLang="ja-JP" sz="1200" b="1" i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HS5-1</a:t>
            </a:r>
            <a:r>
              <a:rPr lang="en-US" altLang="ja-JP" sz="1200" b="1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ouble-stranded RNA</a:t>
            </a:r>
            <a:endParaRPr lang="ja-JP" altLang="ja-JP" sz="105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04681"/>
            <a:ext cx="6858000" cy="5143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6702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595</Words>
  <Application>Microsoft Office PowerPoint</Application>
  <PresentationFormat>画面に合わせる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3" baseType="lpstr">
      <vt:lpstr>ＭＳ Ｐゴシック</vt:lpstr>
      <vt:lpstr>ＭＳ 明朝</vt:lpstr>
      <vt:lpstr>Arial</vt:lpstr>
      <vt:lpstr>Calibri</vt:lpstr>
      <vt:lpstr>Calibri Light</vt:lpstr>
      <vt:lpstr>Century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筑波大学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賀康博</dc:creator>
  <cp:lastModifiedBy>石賀康博</cp:lastModifiedBy>
  <cp:revision>3</cp:revision>
  <dcterms:created xsi:type="dcterms:W3CDTF">2021-06-14T00:01:50Z</dcterms:created>
  <dcterms:modified xsi:type="dcterms:W3CDTF">2021-06-14T00:13:18Z</dcterms:modified>
</cp:coreProperties>
</file>